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18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2FB2"/>
    <a:srgbClr val="3F30AE"/>
    <a:srgbClr val="2B21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13C3C43-66A3-D14B-B763-F96334CFA2A4}" v="3" dt="2021-09-19T16:27:13.14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9890" autoAdjust="0"/>
    <p:restoredTop sz="95390" autoAdjust="0"/>
  </p:normalViewPr>
  <p:slideViewPr>
    <p:cSldViewPr snapToGrid="0">
      <p:cViewPr varScale="1">
        <p:scale>
          <a:sx n="59" d="100"/>
          <a:sy n="59" d="100"/>
        </p:scale>
        <p:origin x="291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ioce Mario" userId="64a03e3b-6f49-4619-8d84-1318f0838d14" providerId="ADAL" clId="{79C5B48F-0E18-7E45-A271-F817588EEB64}"/>
    <pc:docChg chg="custSel modSld">
      <pc:chgData name="Cioce Mario" userId="64a03e3b-6f49-4619-8d84-1318f0838d14" providerId="ADAL" clId="{79C5B48F-0E18-7E45-A271-F817588EEB64}" dt="2021-09-02T04:46:28.760" v="180" actId="1076"/>
      <pc:docMkLst>
        <pc:docMk/>
      </pc:docMkLst>
      <pc:sldChg chg="modSp mod">
        <pc:chgData name="Cioce Mario" userId="64a03e3b-6f49-4619-8d84-1318f0838d14" providerId="ADAL" clId="{79C5B48F-0E18-7E45-A271-F817588EEB64}" dt="2021-09-02T04:42:22.567" v="167" actId="1037"/>
        <pc:sldMkLst>
          <pc:docMk/>
          <pc:sldMk cId="2982597535" sldId="267"/>
        </pc:sldMkLst>
        <pc:spChg chg="mod">
          <ac:chgData name="Cioce Mario" userId="64a03e3b-6f49-4619-8d84-1318f0838d14" providerId="ADAL" clId="{79C5B48F-0E18-7E45-A271-F817588EEB64}" dt="2021-09-02T04:42:00.417" v="156" actId="115"/>
          <ac:spMkLst>
            <pc:docMk/>
            <pc:sldMk cId="2982597535" sldId="267"/>
            <ac:spMk id="11" creationId="{00000000-0000-0000-0000-000000000000}"/>
          </ac:spMkLst>
        </pc:spChg>
        <pc:spChg chg="mod">
          <ac:chgData name="Cioce Mario" userId="64a03e3b-6f49-4619-8d84-1318f0838d14" providerId="ADAL" clId="{79C5B48F-0E18-7E45-A271-F817588EEB64}" dt="2021-09-02T04:42:22.567" v="167" actId="1037"/>
          <ac:spMkLst>
            <pc:docMk/>
            <pc:sldMk cId="2982597535" sldId="267"/>
            <ac:spMk id="12" creationId="{00000000-0000-0000-0000-000000000000}"/>
          </ac:spMkLst>
        </pc:spChg>
        <pc:spChg chg="mod">
          <ac:chgData name="Cioce Mario" userId="64a03e3b-6f49-4619-8d84-1318f0838d14" providerId="ADAL" clId="{79C5B48F-0E18-7E45-A271-F817588EEB64}" dt="2021-09-02T04:41:57.365" v="155" actId="115"/>
          <ac:spMkLst>
            <pc:docMk/>
            <pc:sldMk cId="2982597535" sldId="267"/>
            <ac:spMk id="13" creationId="{00000000-0000-0000-0000-000000000000}"/>
          </ac:spMkLst>
        </pc:spChg>
        <pc:spChg chg="mod">
          <ac:chgData name="Cioce Mario" userId="64a03e3b-6f49-4619-8d84-1318f0838d14" providerId="ADAL" clId="{79C5B48F-0E18-7E45-A271-F817588EEB64}" dt="2021-09-02T04:42:22.567" v="167" actId="1037"/>
          <ac:spMkLst>
            <pc:docMk/>
            <pc:sldMk cId="2982597535" sldId="267"/>
            <ac:spMk id="22" creationId="{00000000-0000-0000-0000-000000000000}"/>
          </ac:spMkLst>
        </pc:spChg>
        <pc:spChg chg="mod">
          <ac:chgData name="Cioce Mario" userId="64a03e3b-6f49-4619-8d84-1318f0838d14" providerId="ADAL" clId="{79C5B48F-0E18-7E45-A271-F817588EEB64}" dt="2021-09-02T04:42:06.095" v="157" actId="115"/>
          <ac:spMkLst>
            <pc:docMk/>
            <pc:sldMk cId="2982597535" sldId="267"/>
            <ac:spMk id="27" creationId="{00000000-0000-0000-0000-000000000000}"/>
          </ac:spMkLst>
        </pc:spChg>
        <pc:spChg chg="mod">
          <ac:chgData name="Cioce Mario" userId="64a03e3b-6f49-4619-8d84-1318f0838d14" providerId="ADAL" clId="{79C5B48F-0E18-7E45-A271-F817588EEB64}" dt="2021-09-02T04:42:08.756" v="158" actId="115"/>
          <ac:spMkLst>
            <pc:docMk/>
            <pc:sldMk cId="2982597535" sldId="267"/>
            <ac:spMk id="28" creationId="{00000000-0000-0000-0000-000000000000}"/>
          </ac:spMkLst>
        </pc:spChg>
      </pc:sldChg>
      <pc:sldChg chg="addSp modSp mod">
        <pc:chgData name="Cioce Mario" userId="64a03e3b-6f49-4619-8d84-1318f0838d14" providerId="ADAL" clId="{79C5B48F-0E18-7E45-A271-F817588EEB64}" dt="2021-09-02T04:46:28.760" v="180" actId="1076"/>
        <pc:sldMkLst>
          <pc:docMk/>
          <pc:sldMk cId="2026329344" sldId="322"/>
        </pc:sldMkLst>
        <pc:spChg chg="add mod">
          <ac:chgData name="Cioce Mario" userId="64a03e3b-6f49-4619-8d84-1318f0838d14" providerId="ADAL" clId="{79C5B48F-0E18-7E45-A271-F817588EEB64}" dt="2021-09-02T04:39:43.220" v="112" actId="20577"/>
          <ac:spMkLst>
            <pc:docMk/>
            <pc:sldMk cId="2026329344" sldId="322"/>
            <ac:spMk id="3" creationId="{478235C5-D957-F846-846C-C8C605F9324B}"/>
          </ac:spMkLst>
        </pc:spChg>
        <pc:spChg chg="mod">
          <ac:chgData name="Cioce Mario" userId="64a03e3b-6f49-4619-8d84-1318f0838d14" providerId="ADAL" clId="{79C5B48F-0E18-7E45-A271-F817588EEB64}" dt="2021-09-01T21:12:47.320" v="6" actId="1036"/>
          <ac:spMkLst>
            <pc:docMk/>
            <pc:sldMk cId="2026329344" sldId="322"/>
            <ac:spMk id="35" creationId="{44FD01A7-2E06-4243-A8FA-33687C5F61AF}"/>
          </ac:spMkLst>
        </pc:spChg>
        <pc:spChg chg="add mod">
          <ac:chgData name="Cioce Mario" userId="64a03e3b-6f49-4619-8d84-1318f0838d14" providerId="ADAL" clId="{79C5B48F-0E18-7E45-A271-F817588EEB64}" dt="2021-09-02T04:40:28.985" v="116"/>
          <ac:spMkLst>
            <pc:docMk/>
            <pc:sldMk cId="2026329344" sldId="322"/>
            <ac:spMk id="36" creationId="{0E5FBBFC-6E03-4B49-9523-F31A33ACB661}"/>
          </ac:spMkLst>
        </pc:spChg>
        <pc:spChg chg="add mod">
          <ac:chgData name="Cioce Mario" userId="64a03e3b-6f49-4619-8d84-1318f0838d14" providerId="ADAL" clId="{79C5B48F-0E18-7E45-A271-F817588EEB64}" dt="2021-09-02T04:43:21.190" v="178" actId="20577"/>
          <ac:spMkLst>
            <pc:docMk/>
            <pc:sldMk cId="2026329344" sldId="322"/>
            <ac:spMk id="37" creationId="{45904ECB-DF5E-5E4E-8F5C-706D181D4110}"/>
          </ac:spMkLst>
        </pc:spChg>
        <pc:grpChg chg="mod">
          <ac:chgData name="Cioce Mario" userId="64a03e3b-6f49-4619-8d84-1318f0838d14" providerId="ADAL" clId="{79C5B48F-0E18-7E45-A271-F817588EEB64}" dt="2021-09-02T04:38:41.432" v="8" actId="1076"/>
          <ac:grpSpMkLst>
            <pc:docMk/>
            <pc:sldMk cId="2026329344" sldId="322"/>
            <ac:grpSpMk id="4" creationId="{00000000-0000-0000-0000-000000000000}"/>
          </ac:grpSpMkLst>
        </pc:grpChg>
        <pc:grpChg chg="add mod">
          <ac:chgData name="Cioce Mario" userId="64a03e3b-6f49-4619-8d84-1318f0838d14" providerId="ADAL" clId="{79C5B48F-0E18-7E45-A271-F817588EEB64}" dt="2021-09-02T04:40:08.421" v="114" actId="1076"/>
          <ac:grpSpMkLst>
            <pc:docMk/>
            <pc:sldMk cId="2026329344" sldId="322"/>
            <ac:grpSpMk id="5" creationId="{81C8952B-E109-8247-B16C-76AAEB63AB63}"/>
          </ac:grpSpMkLst>
        </pc:grpChg>
        <pc:grpChg chg="mod">
          <ac:chgData name="Cioce Mario" userId="64a03e3b-6f49-4619-8d84-1318f0838d14" providerId="ADAL" clId="{79C5B48F-0E18-7E45-A271-F817588EEB64}" dt="2021-09-02T04:38:39.601" v="7" actId="1076"/>
          <ac:grpSpMkLst>
            <pc:docMk/>
            <pc:sldMk cId="2026329344" sldId="322"/>
            <ac:grpSpMk id="26" creationId="{00000000-0000-0000-0000-000000000000}"/>
          </ac:grpSpMkLst>
        </pc:grpChg>
        <pc:picChg chg="add mod">
          <ac:chgData name="Cioce Mario" userId="64a03e3b-6f49-4619-8d84-1318f0838d14" providerId="ADAL" clId="{79C5B48F-0E18-7E45-A271-F817588EEB64}" dt="2021-09-02T04:46:28.760" v="180" actId="1076"/>
          <ac:picMkLst>
            <pc:docMk/>
            <pc:sldMk cId="2026329344" sldId="322"/>
            <ac:picMk id="38" creationId="{1E953B70-2F11-8F42-B84F-C133D61F6261}"/>
          </ac:picMkLst>
        </pc:picChg>
        <pc:picChg chg="mod">
          <ac:chgData name="Cioce Mario" userId="64a03e3b-6f49-4619-8d84-1318f0838d14" providerId="ADAL" clId="{79C5B48F-0E18-7E45-A271-F817588EEB64}" dt="2021-09-02T04:40:13.899" v="115" actId="1076"/>
          <ac:picMkLst>
            <pc:docMk/>
            <pc:sldMk cId="2026329344" sldId="322"/>
            <ac:picMk id="62" creationId="{00000000-0000-0000-0000-000000000000}"/>
          </ac:picMkLst>
        </pc:picChg>
      </pc:sldChg>
    </pc:docChg>
  </pc:docChgLst>
  <pc:docChgLst>
    <pc:chgData name="Cioce Mario" userId="64a03e3b-6f49-4619-8d84-1318f0838d14" providerId="ADAL" clId="{D13C3C43-66A3-D14B-B763-F96334CFA2A4}"/>
    <pc:docChg chg="modSld">
      <pc:chgData name="Cioce Mario" userId="64a03e3b-6f49-4619-8d84-1318f0838d14" providerId="ADAL" clId="{D13C3C43-66A3-D14B-B763-F96334CFA2A4}" dt="2021-09-19T16:28:56.764" v="62" actId="1035"/>
      <pc:docMkLst>
        <pc:docMk/>
      </pc:docMkLst>
      <pc:sldChg chg="addSp delSp modSp mod">
        <pc:chgData name="Cioce Mario" userId="64a03e3b-6f49-4619-8d84-1318f0838d14" providerId="ADAL" clId="{D13C3C43-66A3-D14B-B763-F96334CFA2A4}" dt="2021-09-19T16:28:42.636" v="52" actId="20577"/>
        <pc:sldMkLst>
          <pc:docMk/>
          <pc:sldMk cId="4253236276" sldId="265"/>
        </pc:sldMkLst>
        <pc:spChg chg="mod">
          <ac:chgData name="Cioce Mario" userId="64a03e3b-6f49-4619-8d84-1318f0838d14" providerId="ADAL" clId="{D13C3C43-66A3-D14B-B763-F96334CFA2A4}" dt="2021-09-19T16:28:42.636" v="52" actId="20577"/>
          <ac:spMkLst>
            <pc:docMk/>
            <pc:sldMk cId="4253236276" sldId="265"/>
            <ac:spMk id="9" creationId="{00000000-0000-0000-0000-000000000000}"/>
          </ac:spMkLst>
        </pc:spChg>
        <pc:spChg chg="mod">
          <ac:chgData name="Cioce Mario" userId="64a03e3b-6f49-4619-8d84-1318f0838d14" providerId="ADAL" clId="{D13C3C43-66A3-D14B-B763-F96334CFA2A4}" dt="2021-09-19T16:27:13.141" v="16" actId="166"/>
          <ac:spMkLst>
            <pc:docMk/>
            <pc:sldMk cId="4253236276" sldId="265"/>
            <ac:spMk id="89" creationId="{00000000-0000-0000-0000-000000000000}"/>
          </ac:spMkLst>
        </pc:spChg>
        <pc:grpChg chg="add">
          <ac:chgData name="Cioce Mario" userId="64a03e3b-6f49-4619-8d84-1318f0838d14" providerId="ADAL" clId="{D13C3C43-66A3-D14B-B763-F96334CFA2A4}" dt="2021-09-19T16:26:53.332" v="14" actId="164"/>
          <ac:grpSpMkLst>
            <pc:docMk/>
            <pc:sldMk cId="4253236276" sldId="265"/>
            <ac:grpSpMk id="8" creationId="{B49E8D18-983C-6F4C-8032-D864FD24E830}"/>
          </ac:grpSpMkLst>
        </pc:grpChg>
        <pc:grpChg chg="del">
          <ac:chgData name="Cioce Mario" userId="64a03e3b-6f49-4619-8d84-1318f0838d14" providerId="ADAL" clId="{D13C3C43-66A3-D14B-B763-F96334CFA2A4}" dt="2021-09-19T16:24:33.420" v="8" actId="165"/>
          <ac:grpSpMkLst>
            <pc:docMk/>
            <pc:sldMk cId="4253236276" sldId="265"/>
            <ac:grpSpMk id="11" creationId="{00000000-0000-0000-0000-000000000000}"/>
          </ac:grpSpMkLst>
        </pc:grpChg>
        <pc:picChg chg="mod topLvl modCrop">
          <ac:chgData name="Cioce Mario" userId="64a03e3b-6f49-4619-8d84-1318f0838d14" providerId="ADAL" clId="{D13C3C43-66A3-D14B-B763-F96334CFA2A4}" dt="2021-09-19T16:26:59.029" v="15" actId="167"/>
          <ac:picMkLst>
            <pc:docMk/>
            <pc:sldMk cId="4253236276" sldId="265"/>
            <ac:picMk id="5" creationId="{00000000-0000-0000-0000-000000000000}"/>
          </ac:picMkLst>
        </pc:picChg>
        <pc:picChg chg="topLvl">
          <ac:chgData name="Cioce Mario" userId="64a03e3b-6f49-4619-8d84-1318f0838d14" providerId="ADAL" clId="{D13C3C43-66A3-D14B-B763-F96334CFA2A4}" dt="2021-09-19T16:24:33.420" v="8" actId="165"/>
          <ac:picMkLst>
            <pc:docMk/>
            <pc:sldMk cId="4253236276" sldId="265"/>
            <ac:picMk id="10" creationId="{00000000-0000-0000-0000-000000000000}"/>
          </ac:picMkLst>
        </pc:picChg>
        <pc:picChg chg="mod topLvl">
          <ac:chgData name="Cioce Mario" userId="64a03e3b-6f49-4619-8d84-1318f0838d14" providerId="ADAL" clId="{D13C3C43-66A3-D14B-B763-F96334CFA2A4}" dt="2021-09-19T16:27:13.141" v="16" actId="166"/>
          <ac:picMkLst>
            <pc:docMk/>
            <pc:sldMk cId="4253236276" sldId="265"/>
            <ac:picMk id="14" creationId="{00000000-0000-0000-0000-000000000000}"/>
          </ac:picMkLst>
        </pc:picChg>
        <pc:picChg chg="topLvl">
          <ac:chgData name="Cioce Mario" userId="64a03e3b-6f49-4619-8d84-1318f0838d14" providerId="ADAL" clId="{D13C3C43-66A3-D14B-B763-F96334CFA2A4}" dt="2021-09-19T16:24:33.420" v="8" actId="165"/>
          <ac:picMkLst>
            <pc:docMk/>
            <pc:sldMk cId="4253236276" sldId="265"/>
            <ac:picMk id="17" creationId="{00000000-0000-0000-0000-000000000000}"/>
          </ac:picMkLst>
        </pc:picChg>
        <pc:picChg chg="add mod modCrop">
          <ac:chgData name="Cioce Mario" userId="64a03e3b-6f49-4619-8d84-1318f0838d14" providerId="ADAL" clId="{D13C3C43-66A3-D14B-B763-F96334CFA2A4}" dt="2021-09-19T16:25:52.574" v="13" actId="1036"/>
          <ac:picMkLst>
            <pc:docMk/>
            <pc:sldMk cId="4253236276" sldId="265"/>
            <ac:picMk id="91" creationId="{4A2E0BD5-A64C-184E-B93F-FEBAC7F57570}"/>
          </ac:picMkLst>
        </pc:picChg>
      </pc:sldChg>
      <pc:sldChg chg="modSp mod">
        <pc:chgData name="Cioce Mario" userId="64a03e3b-6f49-4619-8d84-1318f0838d14" providerId="ADAL" clId="{D13C3C43-66A3-D14B-B763-F96334CFA2A4}" dt="2021-09-19T16:28:19.565" v="38" actId="20577"/>
        <pc:sldMkLst>
          <pc:docMk/>
          <pc:sldMk cId="2982597535" sldId="267"/>
        </pc:sldMkLst>
        <pc:spChg chg="mod">
          <ac:chgData name="Cioce Mario" userId="64a03e3b-6f49-4619-8d84-1318f0838d14" providerId="ADAL" clId="{D13C3C43-66A3-D14B-B763-F96334CFA2A4}" dt="2021-09-19T16:28:19.565" v="38" actId="20577"/>
          <ac:spMkLst>
            <pc:docMk/>
            <pc:sldMk cId="2982597535" sldId="267"/>
            <ac:spMk id="40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8:00.461" v="27" actId="20577"/>
        <pc:sldMkLst>
          <pc:docMk/>
          <pc:sldMk cId="571963827" sldId="288"/>
        </pc:sldMkLst>
        <pc:spChg chg="mod">
          <ac:chgData name="Cioce Mario" userId="64a03e3b-6f49-4619-8d84-1318f0838d14" providerId="ADAL" clId="{D13C3C43-66A3-D14B-B763-F96334CFA2A4}" dt="2021-09-19T16:28:00.461" v="27" actId="20577"/>
          <ac:spMkLst>
            <pc:docMk/>
            <pc:sldMk cId="571963827" sldId="288"/>
            <ac:spMk id="154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8:56.764" v="62" actId="1035"/>
        <pc:sldMkLst>
          <pc:docMk/>
          <pc:sldMk cId="2786359011" sldId="295"/>
        </pc:sldMkLst>
        <pc:spChg chg="mod">
          <ac:chgData name="Cioce Mario" userId="64a03e3b-6f49-4619-8d84-1318f0838d14" providerId="ADAL" clId="{D13C3C43-66A3-D14B-B763-F96334CFA2A4}" dt="2021-09-19T16:28:56.764" v="62" actId="1035"/>
          <ac:spMkLst>
            <pc:docMk/>
            <pc:sldMk cId="2786359011" sldId="295"/>
            <ac:spMk id="4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8:07.509" v="31" actId="20577"/>
        <pc:sldMkLst>
          <pc:docMk/>
          <pc:sldMk cId="1671896768" sldId="306"/>
        </pc:sldMkLst>
        <pc:spChg chg="mod">
          <ac:chgData name="Cioce Mario" userId="64a03e3b-6f49-4619-8d84-1318f0838d14" providerId="ADAL" clId="{D13C3C43-66A3-D14B-B763-F96334CFA2A4}" dt="2021-09-19T16:28:07.509" v="31" actId="20577"/>
          <ac:spMkLst>
            <pc:docMk/>
            <pc:sldMk cId="1671896768" sldId="306"/>
            <ac:spMk id="238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7:50.963" v="23" actId="1035"/>
        <pc:sldMkLst>
          <pc:docMk/>
          <pc:sldMk cId="3894059636" sldId="309"/>
        </pc:sldMkLst>
        <pc:spChg chg="mod">
          <ac:chgData name="Cioce Mario" userId="64a03e3b-6f49-4619-8d84-1318f0838d14" providerId="ADAL" clId="{D13C3C43-66A3-D14B-B763-F96334CFA2A4}" dt="2021-09-19T16:27:50.963" v="23" actId="1035"/>
          <ac:spMkLst>
            <pc:docMk/>
            <pc:sldMk cId="3894059636" sldId="309"/>
            <ac:spMk id="12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8:30.290" v="44" actId="113"/>
        <pc:sldMkLst>
          <pc:docMk/>
          <pc:sldMk cId="4073516865" sldId="315"/>
        </pc:sldMkLst>
        <pc:spChg chg="mod">
          <ac:chgData name="Cioce Mario" userId="64a03e3b-6f49-4619-8d84-1318f0838d14" providerId="ADAL" clId="{D13C3C43-66A3-D14B-B763-F96334CFA2A4}" dt="2021-09-19T16:28:30.290" v="44" actId="113"/>
          <ac:spMkLst>
            <pc:docMk/>
            <pc:sldMk cId="4073516865" sldId="315"/>
            <ac:spMk id="19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7:37.112" v="17" actId="1076"/>
        <pc:sldMkLst>
          <pc:docMk/>
          <pc:sldMk cId="3537186155" sldId="318"/>
        </pc:sldMkLst>
        <pc:spChg chg="mod">
          <ac:chgData name="Cioce Mario" userId="64a03e3b-6f49-4619-8d84-1318f0838d14" providerId="ADAL" clId="{D13C3C43-66A3-D14B-B763-F96334CFA2A4}" dt="2021-09-19T16:27:37.112" v="17" actId="1076"/>
          <ac:spMkLst>
            <pc:docMk/>
            <pc:sldMk cId="3537186155" sldId="318"/>
            <ac:spMk id="42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7:44.638" v="20" actId="1035"/>
        <pc:sldMkLst>
          <pc:docMk/>
          <pc:sldMk cId="3023921057" sldId="319"/>
        </pc:sldMkLst>
        <pc:spChg chg="mod">
          <ac:chgData name="Cioce Mario" userId="64a03e3b-6f49-4619-8d84-1318f0838d14" providerId="ADAL" clId="{D13C3C43-66A3-D14B-B763-F96334CFA2A4}" dt="2021-09-19T16:27:44.638" v="20" actId="1035"/>
          <ac:spMkLst>
            <pc:docMk/>
            <pc:sldMk cId="3023921057" sldId="319"/>
            <ac:spMk id="16" creationId="{00000000-0000-0000-0000-000000000000}"/>
          </ac:spMkLst>
        </pc:spChg>
      </pc:sldChg>
      <pc:sldChg chg="modSp mod">
        <pc:chgData name="Cioce Mario" userId="64a03e3b-6f49-4619-8d84-1318f0838d14" providerId="ADAL" clId="{D13C3C43-66A3-D14B-B763-F96334CFA2A4}" dt="2021-09-19T16:28:13.379" v="34" actId="20577"/>
        <pc:sldMkLst>
          <pc:docMk/>
          <pc:sldMk cId="2026329344" sldId="322"/>
        </pc:sldMkLst>
        <pc:spChg chg="mod">
          <ac:chgData name="Cioce Mario" userId="64a03e3b-6f49-4619-8d84-1318f0838d14" providerId="ADAL" clId="{D13C3C43-66A3-D14B-B763-F96334CFA2A4}" dt="2021-09-19T16:28:13.379" v="34" actId="20577"/>
          <ac:spMkLst>
            <pc:docMk/>
            <pc:sldMk cId="2026329344" sldId="322"/>
            <ac:spMk id="55" creationId="{FFF17211-576E-BE4A-91E8-E451D69D6F28}"/>
          </ac:spMkLst>
        </pc:spChg>
      </pc:sldChg>
      <pc:sldChg chg="modSp mod">
        <pc:chgData name="Cioce Mario" userId="64a03e3b-6f49-4619-8d84-1318f0838d14" providerId="ADAL" clId="{D13C3C43-66A3-D14B-B763-F96334CFA2A4}" dt="2021-09-19T16:28:36.003" v="48" actId="20577"/>
        <pc:sldMkLst>
          <pc:docMk/>
          <pc:sldMk cId="3493107280" sldId="323"/>
        </pc:sldMkLst>
        <pc:spChg chg="mod">
          <ac:chgData name="Cioce Mario" userId="64a03e3b-6f49-4619-8d84-1318f0838d14" providerId="ADAL" clId="{D13C3C43-66A3-D14B-B763-F96334CFA2A4}" dt="2021-09-19T16:28:36.003" v="48" actId="20577"/>
          <ac:spMkLst>
            <pc:docMk/>
            <pc:sldMk cId="3493107280" sldId="323"/>
            <ac:spMk id="6" creationId="{25C2FF52-A6F5-074E-B215-3802942B023D}"/>
          </ac:spMkLst>
        </pc:spChg>
        <pc:graphicFrameChg chg="mod">
          <ac:chgData name="Cioce Mario" userId="64a03e3b-6f49-4619-8d84-1318f0838d14" providerId="ADAL" clId="{D13C3C43-66A3-D14B-B763-F96334CFA2A4}" dt="2021-09-19T16:23:36.702" v="6" actId="1037"/>
          <ac:graphicFrameMkLst>
            <pc:docMk/>
            <pc:sldMk cId="3493107280" sldId="323"/>
            <ac:graphicFrameMk id="14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.cioce\OneDrive%20-%20Universit&#224;%20Campus%20Bio-Medico%20di%20Roma\mesonew\observations%20on%20ARA_FL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.cioce\OneDrive%20-%20Universit&#224;%20Campus%20Bio-Medico%20di%20Roma\mesonew\observations%20on%20ARA_FL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.cioce\OneDrive%20-%20Universit&#224;%20Campus%20Bio-Medico%20di%20Roma\mesonew\observations%20on%20ARA_FL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arachidonate (20:4n6)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281714785651793"/>
          <c:y val="0.17171296296296296"/>
          <c:w val="0.7743435147529637"/>
          <c:h val="0.516812846310877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S1'!$J$10</c:f>
              <c:strCache>
                <c:ptCount val="1"/>
                <c:pt idx="0">
                  <c:v>Ctrl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S1'!$P$11:$P$14</c:f>
                <c:numCache>
                  <c:formatCode>General</c:formatCode>
                  <c:ptCount val="4"/>
                  <c:pt idx="0">
                    <c:v>875.62749826003778</c:v>
                  </c:pt>
                  <c:pt idx="1">
                    <c:v>1800.3051541599702</c:v>
                  </c:pt>
                  <c:pt idx="2">
                    <c:v>2513.2973833510541</c:v>
                  </c:pt>
                  <c:pt idx="3">
                    <c:v>975.93736101820457</c:v>
                  </c:pt>
                </c:numCache>
              </c:numRef>
            </c:plus>
            <c:minus>
              <c:numRef>
                <c:f>'Figure S1'!$P$11:$P$14</c:f>
                <c:numCache>
                  <c:formatCode>General</c:formatCode>
                  <c:ptCount val="4"/>
                  <c:pt idx="0">
                    <c:v>875.62749826003778</c:v>
                  </c:pt>
                  <c:pt idx="1">
                    <c:v>1800.3051541599702</c:v>
                  </c:pt>
                  <c:pt idx="2">
                    <c:v>2513.2973833510541</c:v>
                  </c:pt>
                  <c:pt idx="3">
                    <c:v>975.937361018204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J$11:$J$14</c:f>
              <c:numCache>
                <c:formatCode>General</c:formatCode>
                <c:ptCount val="4"/>
                <c:pt idx="0">
                  <c:v>25381.325759999996</c:v>
                </c:pt>
                <c:pt idx="1">
                  <c:v>52184.441073333328</c:v>
                </c:pt>
                <c:pt idx="2">
                  <c:v>72851.549026666675</c:v>
                </c:pt>
                <c:pt idx="3">
                  <c:v>28288.95178666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37-1340-A0D4-7A86748E4D20}"/>
            </c:ext>
          </c:extLst>
        </c:ser>
        <c:ser>
          <c:idx val="1"/>
          <c:order val="1"/>
          <c:tx>
            <c:strRef>
              <c:f>'Figure S1'!$K$10</c:f>
              <c:strCache>
                <c:ptCount val="1"/>
                <c:pt idx="0">
                  <c:v>Pem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S1'!$L$2:$L$5</c:f>
                <c:numCache>
                  <c:formatCode>General</c:formatCode>
                  <c:ptCount val="4"/>
                  <c:pt idx="0">
                    <c:v>2050.6056044402403</c:v>
                  </c:pt>
                  <c:pt idx="1">
                    <c:v>11819.060640505186</c:v>
                  </c:pt>
                  <c:pt idx="2">
                    <c:v>9455.3835919012345</c:v>
                  </c:pt>
                  <c:pt idx="3">
                    <c:v>10567.137272257163</c:v>
                  </c:pt>
                </c:numCache>
              </c:numRef>
            </c:plus>
            <c:minus>
              <c:numRef>
                <c:f>'for box plot'!#REF!</c:f>
                <c:numCache>
                  <c:formatCode>General</c:formatCode>
                  <c:ptCount val="1"/>
                  <c:pt idx="0">
                    <c:v>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K$11:$K$14</c:f>
              <c:numCache>
                <c:formatCode>General</c:formatCode>
                <c:ptCount val="4"/>
                <c:pt idx="0">
                  <c:v>29145.40346666667</c:v>
                </c:pt>
                <c:pt idx="1">
                  <c:v>185276.21906666667</c:v>
                </c:pt>
                <c:pt idx="2">
                  <c:v>148223.09276666667</c:v>
                </c:pt>
                <c:pt idx="3">
                  <c:v>165651.0021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637-1340-A0D4-7A86748E4D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334728"/>
        <c:axId val="131339432"/>
      </c:barChart>
      <c:catAx>
        <c:axId val="131334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339432"/>
        <c:crosses val="autoZero"/>
        <c:auto val="1"/>
        <c:lblAlgn val="ctr"/>
        <c:lblOffset val="100"/>
        <c:noMultiLvlLbl val="0"/>
      </c:catAx>
      <c:valAx>
        <c:axId val="131339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aw area cou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334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329511133274341"/>
          <c:y val="4.95204412651696E-2"/>
          <c:w val="0.11035768095894727"/>
          <c:h val="0.16825664767853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eicosenoate (20:1n9 or 11)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645409708401832"/>
          <c:y val="0.17559763303086751"/>
          <c:w val="0.75708136482939636"/>
          <c:h val="0.525666247275066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S1'!$N$10</c:f>
              <c:strCache>
                <c:ptCount val="1"/>
                <c:pt idx="0">
                  <c:v>Ctrl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S1'!$O$2:$O$5</c:f>
                <c:numCache>
                  <c:formatCode>General</c:formatCode>
                  <c:ptCount val="4"/>
                  <c:pt idx="0">
                    <c:v>1409.6533907614332</c:v>
                  </c:pt>
                  <c:pt idx="1">
                    <c:v>804.25014716972316</c:v>
                  </c:pt>
                  <c:pt idx="2">
                    <c:v>1821.1187173765934</c:v>
                  </c:pt>
                  <c:pt idx="3">
                    <c:v>595.6182166075879</c:v>
                  </c:pt>
                </c:numCache>
              </c:numRef>
            </c:plus>
            <c:minus>
              <c:numRef>
                <c:f>'Figure S1'!$O$2:$O$5</c:f>
                <c:numCache>
                  <c:formatCode>General</c:formatCode>
                  <c:ptCount val="4"/>
                  <c:pt idx="0">
                    <c:v>1409.6533907614332</c:v>
                  </c:pt>
                  <c:pt idx="1">
                    <c:v>804.25014716972316</c:v>
                  </c:pt>
                  <c:pt idx="2">
                    <c:v>1821.1187173765934</c:v>
                  </c:pt>
                  <c:pt idx="3">
                    <c:v>595.61821660758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N$11:$N$14</c:f>
              <c:numCache>
                <c:formatCode>General</c:formatCode>
                <c:ptCount val="4"/>
                <c:pt idx="0">
                  <c:v>22097.801033333337</c:v>
                </c:pt>
                <c:pt idx="1">
                  <c:v>12607.4678</c:v>
                </c:pt>
                <c:pt idx="2">
                  <c:v>28547.953233333334</c:v>
                </c:pt>
                <c:pt idx="3">
                  <c:v>9336.94263333333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48-894F-A647-F1B6D4F2EC99}"/>
            </c:ext>
          </c:extLst>
        </c:ser>
        <c:ser>
          <c:idx val="1"/>
          <c:order val="1"/>
          <c:tx>
            <c:strRef>
              <c:f>'Figure S1'!$O$10</c:f>
              <c:strCache>
                <c:ptCount val="1"/>
                <c:pt idx="0">
                  <c:v>Pem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S1'!$P$2:$P$5</c:f>
                <c:numCache>
                  <c:formatCode>General</c:formatCode>
                  <c:ptCount val="4"/>
                  <c:pt idx="0">
                    <c:v>1310.4523259493392</c:v>
                  </c:pt>
                  <c:pt idx="1">
                    <c:v>1740.5981586250964</c:v>
                  </c:pt>
                  <c:pt idx="2">
                    <c:v>740.79483924134774</c:v>
                  </c:pt>
                  <c:pt idx="3">
                    <c:v>1858.7432992482011</c:v>
                  </c:pt>
                </c:numCache>
              </c:numRef>
            </c:plus>
            <c:minus>
              <c:numRef>
                <c:f>'Figure S1'!$P$2:$P$5</c:f>
                <c:numCache>
                  <c:formatCode>General</c:formatCode>
                  <c:ptCount val="4"/>
                  <c:pt idx="0">
                    <c:v>1310.4523259493392</c:v>
                  </c:pt>
                  <c:pt idx="1">
                    <c:v>1740.5981586250964</c:v>
                  </c:pt>
                  <c:pt idx="2">
                    <c:v>740.79483924134774</c:v>
                  </c:pt>
                  <c:pt idx="3">
                    <c:v>1858.74329924820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O$11:$O$14</c:f>
              <c:numCache>
                <c:formatCode>General</c:formatCode>
                <c:ptCount val="4"/>
                <c:pt idx="0">
                  <c:v>22876.053233333336</c:v>
                </c:pt>
                <c:pt idx="1">
                  <c:v>27285.708699999999</c:v>
                </c:pt>
                <c:pt idx="2">
                  <c:v>29362.289066666664</c:v>
                </c:pt>
                <c:pt idx="3">
                  <c:v>29137.7581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E48-894F-A647-F1B6D4F2EC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332376"/>
        <c:axId val="131333944"/>
      </c:barChart>
      <c:catAx>
        <c:axId val="131332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333944"/>
        <c:crosses val="autoZero"/>
        <c:auto val="1"/>
        <c:lblAlgn val="ctr"/>
        <c:lblOffset val="100"/>
        <c:noMultiLvlLbl val="0"/>
      </c:catAx>
      <c:valAx>
        <c:axId val="131333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aw area cou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332376"/>
        <c:crosses val="autoZero"/>
        <c:crossBetween val="between"/>
        <c:majorUnit val="10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05986321437134"/>
          <c:y val="6.0015696639252242E-2"/>
          <c:w val="0.13931320999240504"/>
          <c:h val="0.16825664767853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docosahexaenoate (DHA; 22:6n3)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783138646130773"/>
          <c:y val="0.17628546231684256"/>
          <c:w val="0.75477603518848835"/>
          <c:h val="0.496843820396049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S1'!$L$10</c:f>
              <c:strCache>
                <c:ptCount val="1"/>
                <c:pt idx="0">
                  <c:v>Ctrl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L$11:$L$14</c:f>
              <c:numCache>
                <c:formatCode>General</c:formatCode>
                <c:ptCount val="4"/>
                <c:pt idx="0">
                  <c:v>50618.639766666667</c:v>
                </c:pt>
                <c:pt idx="1">
                  <c:v>51948.541433333332</c:v>
                </c:pt>
                <c:pt idx="2">
                  <c:v>64441.611866666666</c:v>
                </c:pt>
                <c:pt idx="3">
                  <c:v>17590.07996666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418-B840-A9DE-0D904737295C}"/>
            </c:ext>
          </c:extLst>
        </c:ser>
        <c:ser>
          <c:idx val="1"/>
          <c:order val="1"/>
          <c:tx>
            <c:strRef>
              <c:f>'Figure S1'!$M$10</c:f>
              <c:strCache>
                <c:ptCount val="1"/>
                <c:pt idx="0">
                  <c:v>Pem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S1'!$N$2:$N$5</c:f>
                <c:numCache>
                  <c:formatCode>General</c:formatCode>
                  <c:ptCount val="4"/>
                  <c:pt idx="0">
                    <c:v>3244.0000149869343</c:v>
                  </c:pt>
                  <c:pt idx="1">
                    <c:v>4894.2577340356474</c:v>
                  </c:pt>
                  <c:pt idx="2">
                    <c:v>7085.9903743351824</c:v>
                  </c:pt>
                  <c:pt idx="3">
                    <c:v>6103.6494414325552</c:v>
                  </c:pt>
                </c:numCache>
              </c:numRef>
            </c:plus>
            <c:minus>
              <c:numRef>
                <c:f>'Figure S1'!$N$2:$N$5</c:f>
                <c:numCache>
                  <c:formatCode>General</c:formatCode>
                  <c:ptCount val="4"/>
                  <c:pt idx="0">
                    <c:v>3244.0000149869343</c:v>
                  </c:pt>
                  <c:pt idx="1">
                    <c:v>4894.2577340356474</c:v>
                  </c:pt>
                  <c:pt idx="2">
                    <c:v>7085.9903743351824</c:v>
                  </c:pt>
                  <c:pt idx="3">
                    <c:v>6103.64944143255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re S1'!$B$9:$B$12</c:f>
              <c:strCache>
                <c:ptCount val="4"/>
                <c:pt idx="0">
                  <c:v>HMC</c:v>
                </c:pt>
                <c:pt idx="1">
                  <c:v>H-2373</c:v>
                </c:pt>
                <c:pt idx="2">
                  <c:v>MSTO-211H</c:v>
                </c:pt>
                <c:pt idx="3">
                  <c:v>HP-1</c:v>
                </c:pt>
              </c:strCache>
            </c:strRef>
          </c:cat>
          <c:val>
            <c:numRef>
              <c:f>'Figure S1'!$M$11:$M$14</c:f>
              <c:numCache>
                <c:formatCode>General</c:formatCode>
                <c:ptCount val="4"/>
                <c:pt idx="0">
                  <c:v>45853.115633333335</c:v>
                </c:pt>
                <c:pt idx="1">
                  <c:v>55459.980766666667</c:v>
                </c:pt>
                <c:pt idx="2">
                  <c:v>111080.35950000001</c:v>
                </c:pt>
                <c:pt idx="3">
                  <c:v>95681.1311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418-B840-A9DE-0D90473729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959208"/>
        <c:axId val="151961952"/>
      </c:barChart>
      <c:catAx>
        <c:axId val="151959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961952"/>
        <c:crosses val="autoZero"/>
        <c:auto val="1"/>
        <c:lblAlgn val="ctr"/>
        <c:lblOffset val="100"/>
        <c:noMultiLvlLbl val="0"/>
      </c:catAx>
      <c:valAx>
        <c:axId val="1519619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aw area cou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959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326937848251315"/>
          <c:y val="3.7568401576399901E-2"/>
          <c:w val="0.13508026881255228"/>
          <c:h val="0.16825664767853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38A1F5-B347-459E-8ADC-3AC15FEE2FD8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D5A8AD-06F9-4A16-9021-4AB43BFB45D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6550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41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679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043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787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152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338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663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862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811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183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239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C3587-C42B-46F5-B1AF-030181638465}" type="datetimeFigureOut">
              <a:rPr lang="en-US" smtClean="0"/>
              <a:t>9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61639-89EE-4D17-985C-463FA531318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387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/>
          <p:cNvGrpSpPr/>
          <p:nvPr/>
        </p:nvGrpSpPr>
        <p:grpSpPr>
          <a:xfrm>
            <a:off x="1396916" y="140665"/>
            <a:ext cx="4179094" cy="2699148"/>
            <a:chOff x="1124200" y="718181"/>
            <a:chExt cx="4179094" cy="2699148"/>
          </a:xfrm>
        </p:grpSpPr>
        <p:graphicFrame>
          <p:nvGraphicFramePr>
            <p:cNvPr id="76" name="Grafico 7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13366288"/>
                </p:ext>
              </p:extLst>
            </p:nvPr>
          </p:nvGraphicFramePr>
          <p:xfrm>
            <a:off x="1124200" y="718181"/>
            <a:ext cx="4179094" cy="26991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0" name="Gruppo 9"/>
            <p:cNvGrpSpPr/>
            <p:nvPr/>
          </p:nvGrpSpPr>
          <p:grpSpPr>
            <a:xfrm>
              <a:off x="2974557" y="1288268"/>
              <a:ext cx="375676" cy="261610"/>
              <a:chOff x="3359202" y="1280613"/>
              <a:chExt cx="454568" cy="261610"/>
            </a:xfrm>
          </p:grpSpPr>
          <p:cxnSp>
            <p:nvCxnSpPr>
              <p:cNvPr id="8" name="Connettore 1 7"/>
              <p:cNvCxnSpPr/>
              <p:nvPr/>
            </p:nvCxnSpPr>
            <p:spPr>
              <a:xfrm>
                <a:off x="3359202" y="1414636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CasellaDiTesto 8"/>
              <p:cNvSpPr txBox="1"/>
              <p:nvPr/>
            </p:nvSpPr>
            <p:spPr>
              <a:xfrm>
                <a:off x="3430086" y="1280613"/>
                <a:ext cx="2936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Gruppo 10"/>
            <p:cNvGrpSpPr/>
            <p:nvPr/>
          </p:nvGrpSpPr>
          <p:grpSpPr>
            <a:xfrm>
              <a:off x="3780273" y="1478557"/>
              <a:ext cx="375676" cy="261610"/>
              <a:chOff x="3417093" y="1270970"/>
              <a:chExt cx="454568" cy="261610"/>
            </a:xfrm>
          </p:grpSpPr>
          <p:cxnSp>
            <p:nvCxnSpPr>
              <p:cNvPr id="12" name="Connettore 1 11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CasellaDiTesto 12"/>
              <p:cNvSpPr txBox="1"/>
              <p:nvPr/>
            </p:nvSpPr>
            <p:spPr>
              <a:xfrm>
                <a:off x="3540463" y="1270970"/>
                <a:ext cx="1833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Gruppo 13"/>
            <p:cNvGrpSpPr/>
            <p:nvPr/>
          </p:nvGrpSpPr>
          <p:grpSpPr>
            <a:xfrm>
              <a:off x="4576406" y="1354876"/>
              <a:ext cx="375676" cy="261610"/>
              <a:chOff x="3417093" y="1280036"/>
              <a:chExt cx="454568" cy="261610"/>
            </a:xfrm>
          </p:grpSpPr>
          <p:cxnSp>
            <p:nvCxnSpPr>
              <p:cNvPr id="15" name="Connettore 1 14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CasellaDiTesto 15"/>
              <p:cNvSpPr txBox="1"/>
              <p:nvPr/>
            </p:nvSpPr>
            <p:spPr>
              <a:xfrm>
                <a:off x="3493152" y="1280036"/>
                <a:ext cx="2936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" name="Gruppo 37"/>
            <p:cNvGrpSpPr/>
            <p:nvPr/>
          </p:nvGrpSpPr>
          <p:grpSpPr>
            <a:xfrm>
              <a:off x="2125205" y="2126693"/>
              <a:ext cx="375676" cy="261610"/>
              <a:chOff x="3417093" y="1227892"/>
              <a:chExt cx="454568" cy="261610"/>
            </a:xfrm>
          </p:grpSpPr>
          <p:cxnSp>
            <p:nvCxnSpPr>
              <p:cNvPr id="39" name="Connettore 1 38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CasellaDiTesto 39"/>
              <p:cNvSpPr txBox="1"/>
              <p:nvPr/>
            </p:nvSpPr>
            <p:spPr>
              <a:xfrm>
                <a:off x="3452928" y="1227892"/>
                <a:ext cx="333746" cy="26161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" name="Gruppo 4"/>
          <p:cNvGrpSpPr/>
          <p:nvPr/>
        </p:nvGrpSpPr>
        <p:grpSpPr>
          <a:xfrm>
            <a:off x="1493168" y="4816890"/>
            <a:ext cx="4179094" cy="2651523"/>
            <a:chOff x="1124200" y="6004002"/>
            <a:chExt cx="4179094" cy="2651523"/>
          </a:xfrm>
        </p:grpSpPr>
        <p:graphicFrame>
          <p:nvGraphicFramePr>
            <p:cNvPr id="81" name="Grafico 8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3438117"/>
                </p:ext>
              </p:extLst>
            </p:nvPr>
          </p:nvGraphicFramePr>
          <p:xfrm>
            <a:off x="1124200" y="6004002"/>
            <a:ext cx="4179094" cy="26515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50" name="Gruppo 49"/>
            <p:cNvGrpSpPr/>
            <p:nvPr/>
          </p:nvGrpSpPr>
          <p:grpSpPr>
            <a:xfrm>
              <a:off x="2052663" y="6765503"/>
              <a:ext cx="375676" cy="261610"/>
              <a:chOff x="3417093" y="1225472"/>
              <a:chExt cx="454568" cy="261610"/>
            </a:xfrm>
          </p:grpSpPr>
          <p:cxnSp>
            <p:nvCxnSpPr>
              <p:cNvPr id="51" name="Connettore 1 50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CasellaDiTesto 51"/>
              <p:cNvSpPr txBox="1"/>
              <p:nvPr/>
            </p:nvSpPr>
            <p:spPr>
              <a:xfrm>
                <a:off x="3464422" y="1225472"/>
                <a:ext cx="3337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" name="Gruppo 58"/>
            <p:cNvGrpSpPr/>
            <p:nvPr/>
          </p:nvGrpSpPr>
          <p:grpSpPr>
            <a:xfrm>
              <a:off x="2810745" y="6626591"/>
              <a:ext cx="375676" cy="261610"/>
              <a:chOff x="3417093" y="1289039"/>
              <a:chExt cx="454568" cy="261610"/>
            </a:xfrm>
          </p:grpSpPr>
          <p:cxnSp>
            <p:nvCxnSpPr>
              <p:cNvPr id="60" name="Connettore 1 59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CasellaDiTesto 60"/>
              <p:cNvSpPr txBox="1"/>
              <p:nvPr/>
            </p:nvSpPr>
            <p:spPr>
              <a:xfrm>
                <a:off x="3439532" y="1289039"/>
                <a:ext cx="27764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5" name="Gruppo 64"/>
            <p:cNvGrpSpPr/>
            <p:nvPr/>
          </p:nvGrpSpPr>
          <p:grpSpPr>
            <a:xfrm>
              <a:off x="4426400" y="6591264"/>
              <a:ext cx="375676" cy="261610"/>
              <a:chOff x="3417093" y="1274062"/>
              <a:chExt cx="454568" cy="261610"/>
            </a:xfrm>
          </p:grpSpPr>
          <p:cxnSp>
            <p:nvCxnSpPr>
              <p:cNvPr id="66" name="Connettore 1 65"/>
              <p:cNvCxnSpPr/>
              <p:nvPr/>
            </p:nvCxnSpPr>
            <p:spPr>
              <a:xfrm>
                <a:off x="3417093" y="142461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CasellaDiTesto 66"/>
              <p:cNvSpPr txBox="1"/>
              <p:nvPr/>
            </p:nvSpPr>
            <p:spPr>
              <a:xfrm>
                <a:off x="3465192" y="1274062"/>
                <a:ext cx="2936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Gruppo 70"/>
            <p:cNvGrpSpPr/>
            <p:nvPr/>
          </p:nvGrpSpPr>
          <p:grpSpPr>
            <a:xfrm>
              <a:off x="3627315" y="6546034"/>
              <a:ext cx="375676" cy="261610"/>
              <a:chOff x="3469647" y="1296082"/>
              <a:chExt cx="454568" cy="261610"/>
            </a:xfrm>
          </p:grpSpPr>
          <p:cxnSp>
            <p:nvCxnSpPr>
              <p:cNvPr id="72" name="Connettore 1 71"/>
              <p:cNvCxnSpPr/>
              <p:nvPr/>
            </p:nvCxnSpPr>
            <p:spPr>
              <a:xfrm>
                <a:off x="3469647" y="1495229"/>
                <a:ext cx="4545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CasellaDiTesto 72"/>
              <p:cNvSpPr txBox="1"/>
              <p:nvPr/>
            </p:nvSpPr>
            <p:spPr>
              <a:xfrm>
                <a:off x="3516976" y="1296082"/>
                <a:ext cx="3337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2" name="CasellaDiTesto 41"/>
          <p:cNvSpPr txBox="1"/>
          <p:nvPr/>
        </p:nvSpPr>
        <p:spPr>
          <a:xfrm>
            <a:off x="-113792" y="-121730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uppo 5"/>
          <p:cNvGrpSpPr/>
          <p:nvPr/>
        </p:nvGrpSpPr>
        <p:grpSpPr>
          <a:xfrm>
            <a:off x="1338350" y="2550368"/>
            <a:ext cx="4179094" cy="2544532"/>
            <a:chOff x="1065634" y="3368514"/>
            <a:chExt cx="4179094" cy="2544532"/>
          </a:xfrm>
        </p:grpSpPr>
        <p:graphicFrame>
          <p:nvGraphicFramePr>
            <p:cNvPr id="80" name="Grafico 7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7905410"/>
                </p:ext>
              </p:extLst>
            </p:nvPr>
          </p:nvGraphicFramePr>
          <p:xfrm>
            <a:off x="1065634" y="3368514"/>
            <a:ext cx="4179094" cy="25445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44" name="Gruppo 43"/>
            <p:cNvGrpSpPr/>
            <p:nvPr/>
          </p:nvGrpSpPr>
          <p:grpSpPr>
            <a:xfrm>
              <a:off x="2220300" y="4269643"/>
              <a:ext cx="349605" cy="261610"/>
              <a:chOff x="3427977" y="1200755"/>
              <a:chExt cx="423022" cy="261610"/>
            </a:xfrm>
          </p:grpSpPr>
          <p:cxnSp>
            <p:nvCxnSpPr>
              <p:cNvPr id="45" name="Connettore 1 44"/>
              <p:cNvCxnSpPr/>
              <p:nvPr/>
            </p:nvCxnSpPr>
            <p:spPr>
              <a:xfrm>
                <a:off x="3437755" y="1424619"/>
                <a:ext cx="41324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CasellaDiTesto 45"/>
              <p:cNvSpPr txBox="1"/>
              <p:nvPr/>
            </p:nvSpPr>
            <p:spPr>
              <a:xfrm>
                <a:off x="3427977" y="1200755"/>
                <a:ext cx="3337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Gruppo 54"/>
            <p:cNvGrpSpPr/>
            <p:nvPr/>
          </p:nvGrpSpPr>
          <p:grpSpPr>
            <a:xfrm>
              <a:off x="3001251" y="4209673"/>
              <a:ext cx="349605" cy="261610"/>
              <a:chOff x="3427977" y="1200755"/>
              <a:chExt cx="423022" cy="261610"/>
            </a:xfrm>
          </p:grpSpPr>
          <p:cxnSp>
            <p:nvCxnSpPr>
              <p:cNvPr id="56" name="Connettore 1 55"/>
              <p:cNvCxnSpPr/>
              <p:nvPr/>
            </p:nvCxnSpPr>
            <p:spPr>
              <a:xfrm>
                <a:off x="3437755" y="1424619"/>
                <a:ext cx="41324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CasellaDiTesto 56"/>
              <p:cNvSpPr txBox="1"/>
              <p:nvPr/>
            </p:nvSpPr>
            <p:spPr>
              <a:xfrm>
                <a:off x="3427977" y="1200755"/>
                <a:ext cx="3337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Gruppo 57"/>
            <p:cNvGrpSpPr/>
            <p:nvPr/>
          </p:nvGrpSpPr>
          <p:grpSpPr>
            <a:xfrm>
              <a:off x="3763011" y="3802016"/>
              <a:ext cx="341524" cy="261610"/>
              <a:chOff x="3437755" y="1270427"/>
              <a:chExt cx="413244" cy="261610"/>
            </a:xfrm>
          </p:grpSpPr>
          <p:cxnSp>
            <p:nvCxnSpPr>
              <p:cNvPr id="62" name="Connettore 1 61"/>
              <p:cNvCxnSpPr/>
              <p:nvPr/>
            </p:nvCxnSpPr>
            <p:spPr>
              <a:xfrm>
                <a:off x="3437755" y="1424619"/>
                <a:ext cx="41324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CasellaDiTesto 62"/>
              <p:cNvSpPr txBox="1"/>
              <p:nvPr/>
            </p:nvSpPr>
            <p:spPr>
              <a:xfrm>
                <a:off x="3498930" y="1270427"/>
                <a:ext cx="2391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4" name="Gruppo 63"/>
            <p:cNvGrpSpPr/>
            <p:nvPr/>
          </p:nvGrpSpPr>
          <p:grpSpPr>
            <a:xfrm>
              <a:off x="4563889" y="3929084"/>
              <a:ext cx="375676" cy="261610"/>
              <a:chOff x="3437755" y="1264255"/>
              <a:chExt cx="413244" cy="261610"/>
            </a:xfrm>
          </p:grpSpPr>
          <p:cxnSp>
            <p:nvCxnSpPr>
              <p:cNvPr id="74" name="Connettore 1 73"/>
              <p:cNvCxnSpPr/>
              <p:nvPr/>
            </p:nvCxnSpPr>
            <p:spPr>
              <a:xfrm>
                <a:off x="3437755" y="1424619"/>
                <a:ext cx="41324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CasellaDiTesto 74"/>
              <p:cNvSpPr txBox="1"/>
              <p:nvPr/>
            </p:nvSpPr>
            <p:spPr>
              <a:xfrm>
                <a:off x="3481512" y="1264255"/>
                <a:ext cx="36948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371861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7DC2CDE34BB87479B9936A53DF00BD6" ma:contentTypeVersion="10" ma:contentTypeDescription="Create a new document." ma:contentTypeScope="" ma:versionID="4d7a215f93ac8711030902ead3adf41b">
  <xsd:schema xmlns:xsd="http://www.w3.org/2001/XMLSchema" xmlns:xs="http://www.w3.org/2001/XMLSchema" xmlns:p="http://schemas.microsoft.com/office/2006/metadata/properties" xmlns:ns3="d193f1a8-93cd-481b-b4fd-b93e55c33ad4" targetNamespace="http://schemas.microsoft.com/office/2006/metadata/properties" ma:root="true" ma:fieldsID="ef20d243c285a38279ae3ee0721caab4" ns3:_="">
    <xsd:import namespace="d193f1a8-93cd-481b-b4fd-b93e55c33ad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193f1a8-93cd-481b-b4fd-b93e55c33ad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D75AF39-8C78-44FD-A7A3-934749585800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d193f1a8-93cd-481b-b4fd-b93e55c33ad4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27FBD7A-95B3-432F-9162-71A495CC3BE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193f1a8-93cd-481b-b4fd-b93e55c33ad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9AE410F-780C-4E03-8528-03DCFEDD1C9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16</TotalTime>
  <Words>40</Words>
  <Application>Microsoft Office PowerPoint</Application>
  <PresentationFormat>A4 (21x29,7 cm)</PresentationFormat>
  <Paragraphs>1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oce Mario</dc:creator>
  <cp:lastModifiedBy>Cioce Mario</cp:lastModifiedBy>
  <cp:revision>1162</cp:revision>
  <cp:lastPrinted>2021-08-27T12:04:07Z</cp:lastPrinted>
  <dcterms:created xsi:type="dcterms:W3CDTF">2021-03-24T15:57:35Z</dcterms:created>
  <dcterms:modified xsi:type="dcterms:W3CDTF">2021-09-20T10:32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7DC2CDE34BB87479B9936A53DF00BD6</vt:lpwstr>
  </property>
</Properties>
</file>